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7" r:id="rId2"/>
    <p:sldId id="256" r:id="rId3"/>
    <p:sldId id="258" r:id="rId4"/>
    <p:sldId id="261" r:id="rId5"/>
    <p:sldId id="262" r:id="rId6"/>
    <p:sldId id="263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1872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5F392E-6420-40C2-BB87-171721C6C15D}" type="datetimeFigureOut">
              <a:rPr lang="en-US" smtClean="0"/>
              <a:pPr/>
              <a:t>11/2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F4C693-EDF1-4704-9B89-DFD9EC9C498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1A910-3056-4996-B72A-11E5E3F433A7}" type="datetimeFigureOut">
              <a:rPr lang="en-US" smtClean="0"/>
              <a:pPr/>
              <a:t>11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A23C-2152-4FEF-B090-72C70D7CA92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1A910-3056-4996-B72A-11E5E3F433A7}" type="datetimeFigureOut">
              <a:rPr lang="en-US" smtClean="0"/>
              <a:pPr/>
              <a:t>11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A23C-2152-4FEF-B090-72C70D7CA92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49" y="366713"/>
            <a:ext cx="1543051" cy="78009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1" y="366713"/>
            <a:ext cx="4476751" cy="78009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1A910-3056-4996-B72A-11E5E3F433A7}" type="datetimeFigureOut">
              <a:rPr lang="en-US" smtClean="0"/>
              <a:pPr/>
              <a:t>11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A23C-2152-4FEF-B090-72C70D7CA92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1A910-3056-4996-B72A-11E5E3F433A7}" type="datetimeFigureOut">
              <a:rPr lang="en-US" smtClean="0"/>
              <a:pPr/>
              <a:t>11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A23C-2152-4FEF-B090-72C70D7CA92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1A910-3056-4996-B72A-11E5E3F433A7}" type="datetimeFigureOut">
              <a:rPr lang="en-US" smtClean="0"/>
              <a:pPr/>
              <a:t>11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A23C-2152-4FEF-B090-72C70D7CA92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1A910-3056-4996-B72A-11E5E3F433A7}" type="datetimeFigureOut">
              <a:rPr lang="en-US" smtClean="0"/>
              <a:pPr/>
              <a:t>11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A23C-2152-4FEF-B090-72C70D7CA92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1A910-3056-4996-B72A-11E5E3F433A7}" type="datetimeFigureOut">
              <a:rPr lang="en-US" smtClean="0"/>
              <a:pPr/>
              <a:t>11/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A23C-2152-4FEF-B090-72C70D7CA92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1A910-3056-4996-B72A-11E5E3F433A7}" type="datetimeFigureOut">
              <a:rPr lang="en-US" smtClean="0"/>
              <a:pPr/>
              <a:t>11/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A23C-2152-4FEF-B090-72C70D7CA92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1A910-3056-4996-B72A-11E5E3F433A7}" type="datetimeFigureOut">
              <a:rPr lang="en-US" smtClean="0"/>
              <a:pPr/>
              <a:t>11/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A23C-2152-4FEF-B090-72C70D7CA92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1A910-3056-4996-B72A-11E5E3F433A7}" type="datetimeFigureOut">
              <a:rPr lang="en-US" smtClean="0"/>
              <a:pPr/>
              <a:t>11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A23C-2152-4FEF-B090-72C70D7CA92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1A910-3056-4996-B72A-11E5E3F433A7}" type="datetimeFigureOut">
              <a:rPr lang="en-US" smtClean="0"/>
              <a:pPr/>
              <a:t>11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3A23C-2152-4FEF-B090-72C70D7CA92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1A910-3056-4996-B72A-11E5E3F433A7}" type="datetimeFigureOut">
              <a:rPr lang="en-US" smtClean="0"/>
              <a:pPr/>
              <a:t>11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83A23C-2152-4FEF-B090-72C70D7CA92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3" Type="http://schemas.openxmlformats.org/officeDocument/2006/relationships/image" Target="../media/image11.jpeg"/><Relationship Id="rId7" Type="http://schemas.openxmlformats.org/officeDocument/2006/relationships/image" Target="../media/image15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10" Type="http://schemas.openxmlformats.org/officeDocument/2006/relationships/image" Target="../media/image18.jpeg"/><Relationship Id="rId4" Type="http://schemas.openxmlformats.org/officeDocument/2006/relationships/image" Target="../media/image12.jpeg"/><Relationship Id="rId9" Type="http://schemas.openxmlformats.org/officeDocument/2006/relationships/image" Target="../media/image17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jpeg"/><Relationship Id="rId3" Type="http://schemas.openxmlformats.org/officeDocument/2006/relationships/image" Target="../media/image20.jpeg"/><Relationship Id="rId7" Type="http://schemas.openxmlformats.org/officeDocument/2006/relationships/image" Target="../media/image24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jpeg"/><Relationship Id="rId5" Type="http://schemas.openxmlformats.org/officeDocument/2006/relationships/image" Target="../media/image22.jpeg"/><Relationship Id="rId10" Type="http://schemas.openxmlformats.org/officeDocument/2006/relationships/image" Target="../media/image27.jpeg"/><Relationship Id="rId4" Type="http://schemas.openxmlformats.org/officeDocument/2006/relationships/image" Target="../media/image21.jpeg"/><Relationship Id="rId9" Type="http://schemas.openxmlformats.org/officeDocument/2006/relationships/image" Target="../media/image26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jpeg"/><Relationship Id="rId3" Type="http://schemas.openxmlformats.org/officeDocument/2006/relationships/image" Target="../media/image29.jpeg"/><Relationship Id="rId7" Type="http://schemas.openxmlformats.org/officeDocument/2006/relationships/image" Target="../media/image33.jpeg"/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jpeg"/><Relationship Id="rId5" Type="http://schemas.openxmlformats.org/officeDocument/2006/relationships/image" Target="../media/image31.jpeg"/><Relationship Id="rId10" Type="http://schemas.openxmlformats.org/officeDocument/2006/relationships/image" Target="../media/image36.jpeg"/><Relationship Id="rId4" Type="http://schemas.openxmlformats.org/officeDocument/2006/relationships/image" Target="../media/image30.jpeg"/><Relationship Id="rId9" Type="http://schemas.openxmlformats.org/officeDocument/2006/relationships/image" Target="../media/image35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jpeg"/><Relationship Id="rId3" Type="http://schemas.openxmlformats.org/officeDocument/2006/relationships/image" Target="../media/image38.jpeg"/><Relationship Id="rId7" Type="http://schemas.openxmlformats.org/officeDocument/2006/relationships/image" Target="../media/image42.jpe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jpeg"/><Relationship Id="rId5" Type="http://schemas.openxmlformats.org/officeDocument/2006/relationships/image" Target="../media/image40.jpeg"/><Relationship Id="rId10" Type="http://schemas.openxmlformats.org/officeDocument/2006/relationships/image" Target="../media/image45.jpeg"/><Relationship Id="rId4" Type="http://schemas.openxmlformats.org/officeDocument/2006/relationships/image" Target="../media/image39.jpeg"/><Relationship Id="rId9" Type="http://schemas.openxmlformats.org/officeDocument/2006/relationships/image" Target="../media/image44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jpeg"/><Relationship Id="rId3" Type="http://schemas.openxmlformats.org/officeDocument/2006/relationships/image" Target="../media/image47.jpeg"/><Relationship Id="rId7" Type="http://schemas.openxmlformats.org/officeDocument/2006/relationships/image" Target="../media/image51.jpeg"/><Relationship Id="rId2" Type="http://schemas.openxmlformats.org/officeDocument/2006/relationships/image" Target="../media/image4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jpeg"/><Relationship Id="rId5" Type="http://schemas.openxmlformats.org/officeDocument/2006/relationships/image" Target="../media/image49.jpeg"/><Relationship Id="rId10" Type="http://schemas.openxmlformats.org/officeDocument/2006/relationships/image" Target="../media/image54.jpeg"/><Relationship Id="rId4" Type="http://schemas.openxmlformats.org/officeDocument/2006/relationships/image" Target="../media/image48.jpeg"/><Relationship Id="rId9" Type="http://schemas.openxmlformats.org/officeDocument/2006/relationships/image" Target="../media/image5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82887" y="4705290"/>
            <a:ext cx="10697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9 week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82888" y="3048000"/>
            <a:ext cx="9904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6 week</a:t>
            </a:r>
          </a:p>
        </p:txBody>
      </p:sp>
      <p:pic>
        <p:nvPicPr>
          <p:cNvPr id="2" name="Picture 4" descr="C:\Users\DELL\Desktop\PLOS ONE\PLOS one\PAS\CTRL\CTRL\5d 2 60X 1(9 week)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657904" y="4205240"/>
            <a:ext cx="2057544" cy="1645920"/>
          </a:xfrm>
          <a:prstGeom prst="rect">
            <a:avLst/>
          </a:prstGeom>
          <a:noFill/>
        </p:spPr>
      </p:pic>
      <p:pic>
        <p:nvPicPr>
          <p:cNvPr id="3" name="Picture 6" descr="C:\Users\DELL\Desktop\PLOS ONE\PLOS one\PAS\CTRL\CTRL\D9  14thwk 6 60X6 (9 week)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764602" y="4206490"/>
            <a:ext cx="2057544" cy="1645920"/>
          </a:xfrm>
          <a:prstGeom prst="rect">
            <a:avLst/>
          </a:prstGeom>
          <a:noFill/>
        </p:spPr>
      </p:pic>
      <p:pic>
        <p:nvPicPr>
          <p:cNvPr id="4" name="Picture 8" descr="C:\Users\DELL\Desktop\PLOS ONE\PLOS one\PAS\CTRL\CTRL ( in paper )\D8 9th wk B4 60X 6 (9 week)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550286" y="4221480"/>
            <a:ext cx="2057544" cy="16459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</p:pic>
      <p:pic>
        <p:nvPicPr>
          <p:cNvPr id="6" name="Picture 9" descr="C:\Users\DELL\Desktop\PLOS ONE\PLOS one\PAS\CTRL\CTRL ( in paper )\D9 6thwk  rat 3 60x 1(6 week)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550126" y="2514772"/>
            <a:ext cx="2057544" cy="16459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</p:pic>
      <p:pic>
        <p:nvPicPr>
          <p:cNvPr id="7" name="Picture 10" descr="C:\Users\DELL\Desktop\PLOS ONE\PLOS one\PAS\CTRL\CTRL\6d 45 cntl 60 X (6 week)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659154" y="2514772"/>
            <a:ext cx="2057544" cy="1645920"/>
          </a:xfrm>
          <a:prstGeom prst="rect">
            <a:avLst/>
          </a:prstGeom>
          <a:noFill/>
        </p:spPr>
      </p:pic>
      <p:pic>
        <p:nvPicPr>
          <p:cNvPr id="8" name="Picture 11" descr="C:\Users\DELL\Desktop\PLOS ONE\PLOS one\PAS\CTRL\CTRL\D8 CONT A 5 60X3 (6 week)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764762" y="2525908"/>
            <a:ext cx="2057544" cy="1645920"/>
          </a:xfrm>
          <a:prstGeom prst="rect">
            <a:avLst/>
          </a:prstGeom>
          <a:noFill/>
        </p:spPr>
      </p:pic>
      <p:pic>
        <p:nvPicPr>
          <p:cNvPr id="10" name="Picture 12" descr="C:\Users\DELL\Desktop\PLOS ONE\PLOS one\PAS\CTRL\CTRL ( in paper )\D9  12thwk  rat 4  60x 4 (3 week)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1550286" y="819789"/>
            <a:ext cx="2057544" cy="16459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</p:pic>
      <p:pic>
        <p:nvPicPr>
          <p:cNvPr id="11" name="Picture 16" descr="C:\Users\DELL\Desktop\PLOS ONE\PLOS one\PAS\CTRL\CTRL\5d 2 60X 6 (3 week).jp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657904" y="834777"/>
            <a:ext cx="2057544" cy="1645920"/>
          </a:xfrm>
          <a:prstGeom prst="rect">
            <a:avLst/>
          </a:prstGeom>
          <a:noFill/>
        </p:spPr>
      </p:pic>
      <p:pic>
        <p:nvPicPr>
          <p:cNvPr id="12" name="Picture 17" descr="C:\Users\DELL\Desktop\PLOS ONE\PLOS one\PAS\CTRL\CTRL\5d 3 60X 2 (3 week).jpg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5762835" y="832850"/>
            <a:ext cx="2057544" cy="1645920"/>
          </a:xfrm>
          <a:prstGeom prst="rect">
            <a:avLst/>
          </a:prstGeom>
          <a:noFill/>
        </p:spPr>
      </p:pic>
      <p:sp>
        <p:nvSpPr>
          <p:cNvPr id="13" name="TextBox 12"/>
          <p:cNvSpPr txBox="1"/>
          <p:nvPr/>
        </p:nvSpPr>
        <p:spPr>
          <a:xfrm>
            <a:off x="682887" y="1219200"/>
            <a:ext cx="10697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3 week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33400" y="133290"/>
            <a:ext cx="85344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Periodic acid-Schiff stained images from three different rats in the control group  - (individual images for Figure 4a- control group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2857" y="5918704"/>
            <a:ext cx="9144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/>
              <a:t>Periodic acid-Schiff stained images of kidney tissue sections from untreated diabetic rats (CTRL) after the 3rd, 6th, and 9th weeks of diabetes induction (n=3/time point). The images on the left were used as representative images in the figure. 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1220460" y="5212378"/>
            <a:ext cx="20572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9 week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220460" y="2914710"/>
            <a:ext cx="19048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6 week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220460" y="1085910"/>
            <a:ext cx="20572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3 week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0" y="5734110"/>
            <a:ext cx="9144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/>
              <a:t>Periodic acid-Schiff stained images of kidney tissue sections from untreated diabetic rats (DM) after the 3</a:t>
            </a:r>
            <a:r>
              <a:rPr lang="en-US" baseline="30000" dirty="0"/>
              <a:t>rd</a:t>
            </a:r>
            <a:r>
              <a:rPr lang="en-US" dirty="0"/>
              <a:t>, 6</a:t>
            </a:r>
            <a:r>
              <a:rPr lang="en-US" baseline="30000" dirty="0"/>
              <a:t>th</a:t>
            </a:r>
            <a:r>
              <a:rPr lang="en-US" dirty="0"/>
              <a:t>, and 9</a:t>
            </a:r>
            <a:r>
              <a:rPr lang="en-US" baseline="30000" dirty="0"/>
              <a:t>th</a:t>
            </a:r>
            <a:r>
              <a:rPr lang="en-US" dirty="0"/>
              <a:t> weeks of diabetes induction (n=3/time point). The images on the left were used as representative images in the figure. </a:t>
            </a:r>
          </a:p>
        </p:txBody>
      </p:sp>
      <p:pic>
        <p:nvPicPr>
          <p:cNvPr id="1042" name="Picture 18" descr="C:\Users\DELL\Desktop\PLOS ONE\PLOS one\PAS\DM\DM in paper\D8 CONT A 5 60X2 (6 week)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062441" y="2317857"/>
            <a:ext cx="2057544" cy="16459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</p:pic>
      <p:pic>
        <p:nvPicPr>
          <p:cNvPr id="1043" name="Picture 19" descr="C:\Users\DELL\Desktop\PLOS ONE\PLOS one\PAS\DM\DM in paper\D8 6th wk A2 60X 2 (9 week)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058530" y="4022066"/>
            <a:ext cx="2057544" cy="16459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</p:pic>
      <p:pic>
        <p:nvPicPr>
          <p:cNvPr id="1044" name="Picture 20" descr="C:\Users\DELL\Desktop\PLOS ONE\PLOS one\PAS\DM\DM in paper\D8 CONT A 5 60X (3 week)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058530" y="609600"/>
            <a:ext cx="2057544" cy="16459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</p:pic>
      <p:pic>
        <p:nvPicPr>
          <p:cNvPr id="1045" name="Picture 21" descr="C:\Users\DELL\Desktop\PLOS ONE\PLOS one\PAS\DM\DM (Others)\5d 9thwk 2 60X  pas cort3 (3 week)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169760" y="636859"/>
            <a:ext cx="2057544" cy="1645920"/>
          </a:xfrm>
          <a:prstGeom prst="rect">
            <a:avLst/>
          </a:prstGeom>
          <a:noFill/>
        </p:spPr>
      </p:pic>
      <p:pic>
        <p:nvPicPr>
          <p:cNvPr id="1046" name="Picture 22" descr="C:\Users\DELL\Desktop\PLOS ONE\PLOS one\PAS\DM\DM (Others)\5d 9thwk 3 60X  pas cort3 (3 week)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6248256" y="638031"/>
            <a:ext cx="2057544" cy="1645920"/>
          </a:xfrm>
          <a:prstGeom prst="rect">
            <a:avLst/>
          </a:prstGeom>
          <a:noFill/>
        </p:spPr>
      </p:pic>
      <p:pic>
        <p:nvPicPr>
          <p:cNvPr id="1047" name="Picture 23" descr="C:\Users\DELL\Desktop\PLOS ONE\PLOS one\PAS\DM\DM (Others)\5d 9thwk 3 60X  pas cort1(6 week)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172260" y="2316607"/>
            <a:ext cx="2057544" cy="1645920"/>
          </a:xfrm>
          <a:prstGeom prst="rect">
            <a:avLst/>
          </a:prstGeom>
          <a:noFill/>
        </p:spPr>
      </p:pic>
      <p:pic>
        <p:nvPicPr>
          <p:cNvPr id="1048" name="Picture 24" descr="C:\Users\DELL\Desktop\PLOS ONE\PLOS one\PAS\DM\DM (Others)\5d 9thwk 3 60X  pas cort2 (6 week)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6248256" y="2323518"/>
            <a:ext cx="2057544" cy="1645920"/>
          </a:xfrm>
          <a:prstGeom prst="rect">
            <a:avLst/>
          </a:prstGeom>
          <a:noFill/>
        </p:spPr>
      </p:pic>
      <p:pic>
        <p:nvPicPr>
          <p:cNvPr id="1049" name="Picture 25" descr="C:\Users\DELL\Desktop\PLOS ONE\PLOS one\PAS\DM\DM (Others)\5d 9thwk 2 60X  pas cort2 (9 week).jp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6248256" y="4007076"/>
            <a:ext cx="2057544" cy="1645920"/>
          </a:xfrm>
          <a:prstGeom prst="rect">
            <a:avLst/>
          </a:prstGeom>
          <a:noFill/>
        </p:spPr>
      </p:pic>
      <p:pic>
        <p:nvPicPr>
          <p:cNvPr id="1050" name="Picture 26" descr="C:\Users\DELL\Desktop\PLOS ONE\PLOS one\PAS\DM\DM (Others)\5d 2 60X 2 (9 week).jpg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4169760" y="4006826"/>
            <a:ext cx="2057544" cy="1645920"/>
          </a:xfrm>
          <a:prstGeom prst="rect">
            <a:avLst/>
          </a:prstGeom>
          <a:noFill/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C6F981F-7F6E-05B8-52C8-B55AB93D44DD}"/>
              </a:ext>
            </a:extLst>
          </p:cNvPr>
          <p:cNvSpPr txBox="1"/>
          <p:nvPr/>
        </p:nvSpPr>
        <p:spPr>
          <a:xfrm>
            <a:off x="552835" y="-49590"/>
            <a:ext cx="85344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Periodic acid-Schiff stained images from three different rats in the DM group  - (individual images for Figure 4a- DM group)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DELL\Desktop\PLOS ONE\PLOS one\PAS\DM+Insu\DM+Insu in paper\D9   12thwk  rat 4 60x 5 (3 week)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24031" y="714784"/>
            <a:ext cx="2057544" cy="16459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</p:pic>
      <p:pic>
        <p:nvPicPr>
          <p:cNvPr id="2051" name="Picture 3" descr="C:\Users\DELL\Desktop\PLOS ONE\PLOS one\PAS\DM+Insu\DM+Insu in paper\D8 9th wk B4 60X 7 (6 week)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624032" y="2423164"/>
            <a:ext cx="2057544" cy="16459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</p:pic>
      <p:pic>
        <p:nvPicPr>
          <p:cNvPr id="2052" name="Picture 4" descr="C:\Users\DELL\Desktop\PLOS ONE\PLOS one\PAS\DM+Insu\DM+Insu in paper\D8 CONT A 5 60X1 (9 week)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638100" y="4145280"/>
            <a:ext cx="2057544" cy="16459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</p:pic>
      <p:pic>
        <p:nvPicPr>
          <p:cNvPr id="2053" name="Picture 5" descr="C:\Users\DELL\Desktop\PLOS ONE\PLOS one\PAS\DM+Insu\DM+Insu (Others)\5d 2 60X 7 (3 week)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821036" y="716034"/>
            <a:ext cx="2057544" cy="1645920"/>
          </a:xfrm>
          <a:prstGeom prst="rect">
            <a:avLst/>
          </a:prstGeom>
          <a:noFill/>
        </p:spPr>
      </p:pic>
      <p:pic>
        <p:nvPicPr>
          <p:cNvPr id="2054" name="Picture 6" descr="C:\Users\DELL\Desktop\PLOS ONE\PLOS one\PAS\DM+Insu\DM+Insu (Others)\5d 2 60X 5 (3 week)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725624" y="728852"/>
            <a:ext cx="2057544" cy="1645920"/>
          </a:xfrm>
          <a:prstGeom prst="rect">
            <a:avLst/>
          </a:prstGeom>
          <a:noFill/>
        </p:spPr>
      </p:pic>
      <p:pic>
        <p:nvPicPr>
          <p:cNvPr id="2055" name="Picture 7" descr="C:\Users\DELL\Desktop\PLOS ONE\PLOS one\PAS\DM+Insu\DM+Insu (Others)\5d 3 60X 1 (6 week)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3740614" y="2423292"/>
            <a:ext cx="2057544" cy="1645920"/>
          </a:xfrm>
          <a:prstGeom prst="rect">
            <a:avLst/>
          </a:prstGeom>
          <a:noFill/>
        </p:spPr>
      </p:pic>
      <p:pic>
        <p:nvPicPr>
          <p:cNvPr id="2056" name="Picture 8" descr="C:\Users\DELL\Desktop\PLOS ONE\PLOS one\PAS\DM+Insu\DM+Insu (Others)\5d 2 60X 3 (6 week)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5836026" y="2423164"/>
            <a:ext cx="2057544" cy="1645920"/>
          </a:xfrm>
          <a:prstGeom prst="rect">
            <a:avLst/>
          </a:prstGeom>
          <a:noFill/>
        </p:spPr>
      </p:pic>
      <p:pic>
        <p:nvPicPr>
          <p:cNvPr id="2057" name="Picture 9" descr="C:\Users\DELL\Desktop\PLOS ONE\PLOS one\PAS\DM+Insu\DM+Insu (Others)\5d 3 60X 4 (9 week).jp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756854" y="4130418"/>
            <a:ext cx="2057544" cy="1645920"/>
          </a:xfrm>
          <a:prstGeom prst="rect">
            <a:avLst/>
          </a:prstGeom>
          <a:noFill/>
        </p:spPr>
      </p:pic>
      <p:pic>
        <p:nvPicPr>
          <p:cNvPr id="2058" name="Picture 10" descr="C:\Users\DELL\Desktop\PLOS ONE\PLOS one\PAS\DM+Insu\DM+Insu (Others)\5d 3 60X 3(9 week).jpg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5867256" y="4115300"/>
            <a:ext cx="2057544" cy="1645920"/>
          </a:xfrm>
          <a:prstGeom prst="rect">
            <a:avLst/>
          </a:prstGeom>
          <a:noFill/>
        </p:spPr>
      </p:pic>
      <p:sp>
        <p:nvSpPr>
          <p:cNvPr id="12" name="TextBox 11"/>
          <p:cNvSpPr txBox="1"/>
          <p:nvPr/>
        </p:nvSpPr>
        <p:spPr>
          <a:xfrm>
            <a:off x="609600" y="4724400"/>
            <a:ext cx="1143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9 week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09600" y="3048000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6 week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609600" y="1219200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3 week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0" y="5867400"/>
            <a:ext cx="9144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/>
              <a:t>Periodic acid-Schiff stained images of kidney tissue sections from untreated diabetic rats (DM+INS) after the 3</a:t>
            </a:r>
            <a:r>
              <a:rPr lang="en-US" baseline="30000" dirty="0"/>
              <a:t>rd</a:t>
            </a:r>
            <a:r>
              <a:rPr lang="en-US" dirty="0"/>
              <a:t>, 6</a:t>
            </a:r>
            <a:r>
              <a:rPr lang="en-US" baseline="30000" dirty="0"/>
              <a:t>th</a:t>
            </a:r>
            <a:r>
              <a:rPr lang="en-US" dirty="0"/>
              <a:t>, and 9</a:t>
            </a:r>
            <a:r>
              <a:rPr lang="en-US" baseline="30000" dirty="0"/>
              <a:t>th</a:t>
            </a:r>
            <a:r>
              <a:rPr lang="en-US" dirty="0"/>
              <a:t> weeks of diabetes induction (n=3/time point). The images on the left were used as representative images in the figure.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7C1189C-B420-C515-EAAB-E662E76097C2}"/>
              </a:ext>
            </a:extLst>
          </p:cNvPr>
          <p:cNvSpPr txBox="1"/>
          <p:nvPr/>
        </p:nvSpPr>
        <p:spPr>
          <a:xfrm>
            <a:off x="552835" y="-49590"/>
            <a:ext cx="85344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Periodic acid-Schiff stained images from three different rats in the DM+ INS group  - (individual images for Figure 4a- DM+ INS group)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2057400" y="685800"/>
            <a:ext cx="6278880" cy="5029200"/>
            <a:chOff x="2255520" y="1051560"/>
            <a:chExt cx="6278880" cy="5029200"/>
          </a:xfrm>
        </p:grpSpPr>
        <p:pic>
          <p:nvPicPr>
            <p:cNvPr id="1026" name="Picture 2" descr="C:\Users\DELL\Desktop\PLOS ONE\PLOS one\MT\CTRL\CTRL in paper\D8 Cntrol 60 X 9 (6 week)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255520" y="2743200"/>
              <a:ext cx="2057544" cy="164592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</p:pic>
        <p:pic>
          <p:nvPicPr>
            <p:cNvPr id="1027" name="Picture 3" descr="C:\Users\DELL\Desktop\PLOS ONE\PLOS one\MT\CTRL\CTRL in paper\D8 Cntrol 60 X 7 (3 week).jp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255520" y="1051560"/>
              <a:ext cx="2057544" cy="164592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</p:pic>
        <p:pic>
          <p:nvPicPr>
            <p:cNvPr id="1028" name="Picture 4" descr="C:\Users\DELL\Desktop\PLOS ONE\PLOS one\MT\CTRL\CTRL in paper\D8 Cntrol 60 X 8(9 week).jp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255520" y="4434840"/>
              <a:ext cx="2057544" cy="164592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</p:pic>
        <p:pic>
          <p:nvPicPr>
            <p:cNvPr id="2" name="Picture 2" descr="C:\Users\DELL\Desktop\PLOS ONE\PLOS one\MT\CTRL\CTRL (Others)\5D 2 60X 2 (3 week).jpg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4358640" y="1051560"/>
              <a:ext cx="2057544" cy="1645920"/>
            </a:xfrm>
            <a:prstGeom prst="rect">
              <a:avLst/>
            </a:prstGeom>
            <a:noFill/>
          </p:spPr>
        </p:pic>
        <p:pic>
          <p:nvPicPr>
            <p:cNvPr id="3" name="Picture 3" descr="C:\Users\DELL\Desktop\PLOS ONE\PLOS one\MT\CTRL\CTRL (Others)\5D 2 60X 1(3 week).jpg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6461760" y="1051560"/>
              <a:ext cx="2057544" cy="1645920"/>
            </a:xfrm>
            <a:prstGeom prst="rect">
              <a:avLst/>
            </a:prstGeom>
            <a:noFill/>
          </p:spPr>
        </p:pic>
        <p:pic>
          <p:nvPicPr>
            <p:cNvPr id="4" name="Picture 4" descr="C:\Users\DELL\Desktop\PLOS ONE\PLOS one\MT\CTRL\CTRL (Others)\5D 2 60X 6 (6 week).jp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6461760" y="2743200"/>
              <a:ext cx="2057544" cy="1645920"/>
            </a:xfrm>
            <a:prstGeom prst="rect">
              <a:avLst/>
            </a:prstGeom>
            <a:noFill/>
          </p:spPr>
        </p:pic>
        <p:pic>
          <p:nvPicPr>
            <p:cNvPr id="1029" name="Picture 5" descr="C:\Users\DELL\Desktop\PLOS ONE\PLOS one\MT\CTRL\CTRL (Others)\5D 2 60X 3 (6 week).jpg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4358640" y="2743200"/>
              <a:ext cx="2057544" cy="1645920"/>
            </a:xfrm>
            <a:prstGeom prst="rect">
              <a:avLst/>
            </a:prstGeom>
            <a:noFill/>
          </p:spPr>
        </p:pic>
        <p:pic>
          <p:nvPicPr>
            <p:cNvPr id="1030" name="Picture 6" descr="C:\Users\DELL\Desktop\PLOS ONE\PLOS one\MT\CTRL\CTRL (Others)\5D 2 60X 9 (9week).jp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4358640" y="4434840"/>
              <a:ext cx="2057544" cy="1645920"/>
            </a:xfrm>
            <a:prstGeom prst="rect">
              <a:avLst/>
            </a:prstGeom>
            <a:noFill/>
          </p:spPr>
        </p:pic>
        <p:pic>
          <p:nvPicPr>
            <p:cNvPr id="1031" name="Picture 7" descr="C:\Users\DELL\Desktop\PLOS ONE\PLOS one\MT\CTRL\CTRL (Others)\5D 2 60X 8 (9 week).jpg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6476856" y="4434840"/>
              <a:ext cx="2057544" cy="1645920"/>
            </a:xfrm>
            <a:prstGeom prst="rect">
              <a:avLst/>
            </a:prstGeom>
            <a:noFill/>
          </p:spPr>
        </p:pic>
      </p:grpSp>
      <p:sp>
        <p:nvSpPr>
          <p:cNvPr id="11" name="TextBox 10"/>
          <p:cNvSpPr txBox="1"/>
          <p:nvPr/>
        </p:nvSpPr>
        <p:spPr>
          <a:xfrm>
            <a:off x="1143130" y="4724400"/>
            <a:ext cx="10666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9 week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143000" y="3048000"/>
            <a:ext cx="19048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6 week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143130" y="1219200"/>
            <a:ext cx="20572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3 week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33400" y="36493"/>
            <a:ext cx="82296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Masson Trichrome stained images from three different rats in the CTRL group  - (individual images for Figure 4c- CTRL group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0" y="5867400"/>
            <a:ext cx="9144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/>
              <a:t>Masson Trichrome stained images of kidney tissue sections from untreated diabetic rats (CTRL ) after the 3</a:t>
            </a:r>
            <a:r>
              <a:rPr lang="en-US" baseline="30000" dirty="0"/>
              <a:t>rd</a:t>
            </a:r>
            <a:r>
              <a:rPr lang="en-US" dirty="0"/>
              <a:t>, 6</a:t>
            </a:r>
            <a:r>
              <a:rPr lang="en-US" baseline="30000" dirty="0"/>
              <a:t>th</a:t>
            </a:r>
            <a:r>
              <a:rPr lang="en-US" dirty="0"/>
              <a:t>, and 9</a:t>
            </a:r>
            <a:r>
              <a:rPr lang="en-US" baseline="30000" dirty="0"/>
              <a:t>th</a:t>
            </a:r>
            <a:r>
              <a:rPr lang="en-US" dirty="0"/>
              <a:t> weeks of diabetes induction (n=3/time point). The images on the left were used as representative images in the figure.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1126932" y="4953000"/>
            <a:ext cx="9904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9 week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126802" y="3048000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6 week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126932" y="1219200"/>
            <a:ext cx="9904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3 week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33400" y="133290"/>
            <a:ext cx="81534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Masson Trichrome stained images from three different rats in the DM group  - (individual images for Figure 4c- DM group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0" y="5943600"/>
            <a:ext cx="9144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/>
              <a:t>Masson Trichrome stained images of kidney tissue sections from untreated diabetic rats (DM ) after the 3</a:t>
            </a:r>
            <a:r>
              <a:rPr lang="en-US" baseline="30000" dirty="0"/>
              <a:t>rd</a:t>
            </a:r>
            <a:r>
              <a:rPr lang="en-US" dirty="0"/>
              <a:t>, 6</a:t>
            </a:r>
            <a:r>
              <a:rPr lang="en-US" baseline="30000" dirty="0"/>
              <a:t>th</a:t>
            </a:r>
            <a:r>
              <a:rPr lang="en-US" dirty="0"/>
              <a:t>, and 9</a:t>
            </a:r>
            <a:r>
              <a:rPr lang="en-US" baseline="30000" dirty="0"/>
              <a:t>th</a:t>
            </a:r>
            <a:r>
              <a:rPr lang="en-US" dirty="0"/>
              <a:t> weeks of diabetes induction (n=3/time point). The images on the left were used as representative images in the figure. </a:t>
            </a:r>
          </a:p>
        </p:txBody>
      </p:sp>
      <p:grpSp>
        <p:nvGrpSpPr>
          <p:cNvPr id="17" name="Group 16"/>
          <p:cNvGrpSpPr/>
          <p:nvPr/>
        </p:nvGrpSpPr>
        <p:grpSpPr>
          <a:xfrm>
            <a:off x="1965146" y="838200"/>
            <a:ext cx="6264454" cy="5027622"/>
            <a:chOff x="1812890" y="977464"/>
            <a:chExt cx="6264454" cy="5027622"/>
          </a:xfrm>
        </p:grpSpPr>
        <p:pic>
          <p:nvPicPr>
            <p:cNvPr id="2" name="Picture 5" descr="C:\Users\DELL\Desktop\PLOS ONE\PLOS one\MT\DM\DM in paper\D9  4th 12th 60X 5 (6 week)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812890" y="2667000"/>
              <a:ext cx="2057544" cy="164592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</p:pic>
        <p:pic>
          <p:nvPicPr>
            <p:cNvPr id="3" name="Picture 6" descr="C:\Users\DELL\Desktop\PLOS ONE\PLOS one\MT\DM\DM in paper\D8 Cntrol 60 X 2 (3 week).jp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812890" y="977464"/>
              <a:ext cx="2057544" cy="164592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</p:pic>
        <p:pic>
          <p:nvPicPr>
            <p:cNvPr id="4" name="Picture 7" descr="C:\Users\DELL\Desktop\PLOS ONE\PLOS one\MT\DM\DM in paper\D9  3rd  6th 60X (9 week).jp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812890" y="4359166"/>
              <a:ext cx="2057544" cy="164592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</p:pic>
        <p:pic>
          <p:nvPicPr>
            <p:cNvPr id="2050" name="Picture 2" descr="C:\Users\DELL\Desktop\PLOS ONE\PLOS one\MT\DM\DM others\D8 A2  6th 60X 4(3 week).jpg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917732" y="977464"/>
              <a:ext cx="2057544" cy="1645920"/>
            </a:xfrm>
            <a:prstGeom prst="rect">
              <a:avLst/>
            </a:prstGeom>
            <a:noFill/>
          </p:spPr>
        </p:pic>
        <p:pic>
          <p:nvPicPr>
            <p:cNvPr id="2051" name="Picture 3" descr="C:\Users\DELL\Desktop\PLOS ONE\PLOS one\MT\DM\DM others\D8 A2  6th 60X 3 (3 week).jpg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6019800" y="977464"/>
              <a:ext cx="2057544" cy="1645920"/>
            </a:xfrm>
            <a:prstGeom prst="rect">
              <a:avLst/>
            </a:prstGeom>
            <a:noFill/>
          </p:spPr>
        </p:pic>
        <p:pic>
          <p:nvPicPr>
            <p:cNvPr id="2052" name="Picture 4" descr="C:\Users\DELL\Desktop\PLOS ONE\PLOS one\MT\DM\DM others\D9  3rd  6th 60X 2 (6 week).jp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3917732" y="2667000"/>
              <a:ext cx="2057544" cy="1645920"/>
            </a:xfrm>
            <a:prstGeom prst="rect">
              <a:avLst/>
            </a:prstGeom>
            <a:noFill/>
          </p:spPr>
        </p:pic>
        <p:pic>
          <p:nvPicPr>
            <p:cNvPr id="2053" name="Picture 5" descr="C:\Users\DELL\Desktop\PLOS ONE\PLOS one\MT\DM\DM others\D9  3rd  6th 60X 1(6 week).jpg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6019800" y="2665948"/>
              <a:ext cx="2057544" cy="1645920"/>
            </a:xfrm>
            <a:prstGeom prst="rect">
              <a:avLst/>
            </a:prstGeom>
            <a:noFill/>
          </p:spPr>
        </p:pic>
        <p:pic>
          <p:nvPicPr>
            <p:cNvPr id="2054" name="Picture 6" descr="C:\Users\DELL\Desktop\PLOS ONE\PLOS one\MT\DM\DM others\D8 A2  6th 60X 6 (9 week).jp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6019800" y="4343400"/>
              <a:ext cx="2057544" cy="1645920"/>
            </a:xfrm>
            <a:prstGeom prst="rect">
              <a:avLst/>
            </a:prstGeom>
            <a:noFill/>
          </p:spPr>
        </p:pic>
        <p:pic>
          <p:nvPicPr>
            <p:cNvPr id="2055" name="Picture 7" descr="C:\Users\DELL\Desktop\PLOS ONE\PLOS one\MT\DM\DM others\D8 A2  6th 60X 7(9 week).jpg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3917732" y="4359166"/>
              <a:ext cx="2057544" cy="1645920"/>
            </a:xfrm>
            <a:prstGeom prst="rect">
              <a:avLst/>
            </a:prstGeom>
            <a:noFill/>
          </p:spPr>
        </p:pic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8" descr="C:\Users\DELL\Desktop\PLOS ONE\PLOS one\MT\DM+Ins\DM+ Insu in paper\D9  3rd  6th 60X 7(9 week)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81200" y="4100732"/>
            <a:ext cx="2057544" cy="16459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</p:pic>
      <p:pic>
        <p:nvPicPr>
          <p:cNvPr id="3" name="Picture 9" descr="C:\Users\DELL\Desktop\PLOS ONE\PLOS one\MT\DM+Ins\DM+ Insu in paper\D9  4th 12th 60X 3 (3 week)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81200" y="762000"/>
            <a:ext cx="2057544" cy="16459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</p:pic>
      <p:pic>
        <p:nvPicPr>
          <p:cNvPr id="4" name="Picture 10" descr="C:\Users\DELL\Desktop\PLOS ONE\PLOS one\MT\DM+Ins\DM+ Insu in paper\D8 Cntrol 60 X 1(6 week)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981200" y="2424332"/>
            <a:ext cx="2057544" cy="16459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</p:pic>
      <p:pic>
        <p:nvPicPr>
          <p:cNvPr id="3074" name="Picture 2" descr="C:\Users\DELL\Desktop\PLOS ONE\PLOS one\MT\DM+Ins\DM+INS( Others)\D8 B4  9th 60X 5 (3 week)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078600" y="762000"/>
            <a:ext cx="2057544" cy="1645920"/>
          </a:xfrm>
          <a:prstGeom prst="rect">
            <a:avLst/>
          </a:prstGeom>
          <a:noFill/>
        </p:spPr>
      </p:pic>
      <p:pic>
        <p:nvPicPr>
          <p:cNvPr id="3075" name="Picture 3" descr="C:\Users\DELL\Desktop\PLOS ONE\PLOS one\MT\DM+Ins\DM+INS( Others)\D8 B4  9th 60X 4 (3 week)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6175856" y="762000"/>
            <a:ext cx="2057544" cy="1645920"/>
          </a:xfrm>
          <a:prstGeom prst="rect">
            <a:avLst/>
          </a:prstGeom>
          <a:noFill/>
        </p:spPr>
      </p:pic>
      <p:pic>
        <p:nvPicPr>
          <p:cNvPr id="3076" name="Picture 4" descr="C:\Users\DELL\Desktop\PLOS ONE\PLOS one\MT\DM+Ins\DM+INS( Others)\D8 B4  9th 60X (6 week)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086808" y="2424332"/>
            <a:ext cx="2057544" cy="1645920"/>
          </a:xfrm>
          <a:prstGeom prst="rect">
            <a:avLst/>
          </a:prstGeom>
          <a:noFill/>
        </p:spPr>
      </p:pic>
      <p:pic>
        <p:nvPicPr>
          <p:cNvPr id="3077" name="Picture 5" descr="C:\Users\DELL\Desktop\PLOS ONE\PLOS one\MT\DM+Ins\DM+INS( Others)\D8 B4  9th 60X 3(6 week)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6172344" y="2424332"/>
            <a:ext cx="2057544" cy="1645920"/>
          </a:xfrm>
          <a:prstGeom prst="rect">
            <a:avLst/>
          </a:prstGeom>
          <a:noFill/>
        </p:spPr>
      </p:pic>
      <p:pic>
        <p:nvPicPr>
          <p:cNvPr id="3078" name="Picture 6" descr="C:\Users\DELL\Desktop\PLOS ONE\PLOS one\MT\DM+Ins\DM+INS( Others)\5D 2 60X 10 (9 week).jp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4072740" y="4100732"/>
            <a:ext cx="2057544" cy="1645920"/>
          </a:xfrm>
          <a:prstGeom prst="rect">
            <a:avLst/>
          </a:prstGeom>
          <a:noFill/>
          <a:ln>
            <a:noFill/>
          </a:ln>
        </p:spPr>
      </p:pic>
      <p:pic>
        <p:nvPicPr>
          <p:cNvPr id="3079" name="Picture 7" descr="C:\Users\DELL\Desktop\PLOS ONE\PLOS one\MT\DM+Ins\DM+INS( Others)\5D 2 60X 7  ( 9 week).jpg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6158276" y="4100732"/>
            <a:ext cx="2057544" cy="1645920"/>
          </a:xfrm>
          <a:prstGeom prst="rect">
            <a:avLst/>
          </a:prstGeom>
          <a:noFill/>
        </p:spPr>
      </p:pic>
      <p:sp>
        <p:nvSpPr>
          <p:cNvPr id="12" name="TextBox 11"/>
          <p:cNvSpPr txBox="1"/>
          <p:nvPr/>
        </p:nvSpPr>
        <p:spPr>
          <a:xfrm>
            <a:off x="1066800" y="5029200"/>
            <a:ext cx="990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9 week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066800" y="3257490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6 week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066800" y="1581090"/>
            <a:ext cx="990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3 week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81000" y="-8522"/>
            <a:ext cx="85344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Masson Trichrome stained images from three different rats in the DM+ INS group  - (individual images for Figure 4a- DM+ INS group). 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0" y="5867400"/>
            <a:ext cx="9144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/>
              <a:t>Masson Trichrome stained images of kidney tissue sections from untreated diabetic rats (DM + INS ) after the 3</a:t>
            </a:r>
            <a:r>
              <a:rPr lang="en-US" baseline="30000" dirty="0"/>
              <a:t>rd</a:t>
            </a:r>
            <a:r>
              <a:rPr lang="en-US" dirty="0"/>
              <a:t>, 6</a:t>
            </a:r>
            <a:r>
              <a:rPr lang="en-US" baseline="30000" dirty="0"/>
              <a:t>th</a:t>
            </a:r>
            <a:r>
              <a:rPr lang="en-US" dirty="0"/>
              <a:t>, and 9</a:t>
            </a:r>
            <a:r>
              <a:rPr lang="en-US" baseline="30000" dirty="0"/>
              <a:t>th</a:t>
            </a:r>
            <a:r>
              <a:rPr lang="en-US" dirty="0"/>
              <a:t> weeks of diabetes induction (n=3/time point). The images on the left were used as representative images in the figure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7</TotalTime>
  <Words>473</Words>
  <Application>Microsoft Office PowerPoint</Application>
  <PresentationFormat>On-screen Show (4:3)</PresentationFormat>
  <Paragraphs>3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ELL</dc:creator>
  <cp:lastModifiedBy>Rajesh</cp:lastModifiedBy>
  <cp:revision>34</cp:revision>
  <dcterms:created xsi:type="dcterms:W3CDTF">2023-10-11T04:59:49Z</dcterms:created>
  <dcterms:modified xsi:type="dcterms:W3CDTF">2023-11-02T13:14:07Z</dcterms:modified>
</cp:coreProperties>
</file>